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71" d="100"/>
          <a:sy n="171" d="100"/>
        </p:scale>
        <p:origin x="-128" y="-3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37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35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721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920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978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489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586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902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693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416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019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46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Magnetic Disk 3"/>
          <p:cNvSpPr/>
          <p:nvPr/>
        </p:nvSpPr>
        <p:spPr>
          <a:xfrm>
            <a:off x="3921772" y="181993"/>
            <a:ext cx="1296000" cy="794802"/>
          </a:xfrm>
          <a:prstGeom prst="flowChartMagneticDisk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000" dirty="0" err="1" smtClean="0">
                <a:latin typeface="Times New Roman"/>
                <a:cs typeface="Times New Roman"/>
              </a:rPr>
              <a:t>BioGRID</a:t>
            </a:r>
            <a:r>
              <a:rPr lang="en-US" sz="1000" dirty="0" smtClean="0">
                <a:latin typeface="Times New Roman"/>
                <a:cs typeface="Times New Roman"/>
              </a:rPr>
              <a:t> synthetic lethality interactions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5" name="Decision 4"/>
          <p:cNvSpPr/>
          <p:nvPr/>
        </p:nvSpPr>
        <p:spPr>
          <a:xfrm>
            <a:off x="3768933" y="1511640"/>
            <a:ext cx="1598400" cy="986400"/>
          </a:xfrm>
          <a:prstGeom prst="flowChartDecision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evidences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9" name="Straight Arrow Connector 8"/>
          <p:cNvCxnSpPr>
            <a:stCxn id="4" idx="3"/>
            <a:endCxn id="5" idx="0"/>
          </p:cNvCxnSpPr>
          <p:nvPr/>
        </p:nvCxnSpPr>
        <p:spPr>
          <a:xfrm rot="5400000">
            <a:off x="4301531" y="1243398"/>
            <a:ext cx="534845" cy="163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>
            <a:stCxn id="5" idx="3"/>
            <a:endCxn id="21" idx="2"/>
          </p:cNvCxnSpPr>
          <p:nvPr/>
        </p:nvCxnSpPr>
        <p:spPr>
          <a:xfrm flipV="1">
            <a:off x="5367333" y="2004838"/>
            <a:ext cx="604100" cy="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Connector 20"/>
          <p:cNvSpPr/>
          <p:nvPr/>
        </p:nvSpPr>
        <p:spPr>
          <a:xfrm>
            <a:off x="5971433" y="1679038"/>
            <a:ext cx="1566000" cy="651600"/>
          </a:xfrm>
          <a:prstGeom prst="flowChartConnector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Stringent criterion for synthetic lethality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22" name="Connector 21"/>
          <p:cNvSpPr/>
          <p:nvPr/>
        </p:nvSpPr>
        <p:spPr>
          <a:xfrm>
            <a:off x="1606567" y="1679039"/>
            <a:ext cx="1566000" cy="651600"/>
          </a:xfrm>
          <a:prstGeom prst="flowChartConnector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Tolerant criterion for synthetic lethality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24" name="Straight Arrow Connector 23"/>
          <p:cNvCxnSpPr>
            <a:stCxn id="5" idx="1"/>
            <a:endCxn id="22" idx="6"/>
          </p:cNvCxnSpPr>
          <p:nvPr/>
        </p:nvCxnSpPr>
        <p:spPr>
          <a:xfrm rot="10800000">
            <a:off x="3172567" y="2004840"/>
            <a:ext cx="596366" cy="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3358548" y="176307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1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479160" y="1768245"/>
            <a:ext cx="3211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&gt;1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2" name="Magnetic Disk 11"/>
          <p:cNvSpPr/>
          <p:nvPr/>
        </p:nvSpPr>
        <p:spPr>
          <a:xfrm>
            <a:off x="2624133" y="5871680"/>
            <a:ext cx="972000" cy="794802"/>
          </a:xfrm>
          <a:prstGeom prst="flowChartMagneticDisk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Essential genes dataset 1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3" name="Magnetic Disk 12"/>
          <p:cNvSpPr/>
          <p:nvPr/>
        </p:nvSpPr>
        <p:spPr>
          <a:xfrm>
            <a:off x="3596133" y="5871679"/>
            <a:ext cx="972000" cy="794802"/>
          </a:xfrm>
          <a:prstGeom prst="flowChartMagneticDisk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Essential genes dataset 2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4" name="Magnetic Disk 13"/>
          <p:cNvSpPr/>
          <p:nvPr/>
        </p:nvSpPr>
        <p:spPr>
          <a:xfrm>
            <a:off x="4569772" y="5871679"/>
            <a:ext cx="972000" cy="794802"/>
          </a:xfrm>
          <a:prstGeom prst="flowChartMagneticDisk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Essential genes dataset 3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5" name="Magnetic Disk 14"/>
          <p:cNvSpPr/>
          <p:nvPr/>
        </p:nvSpPr>
        <p:spPr>
          <a:xfrm>
            <a:off x="5541772" y="5871680"/>
            <a:ext cx="972000" cy="794802"/>
          </a:xfrm>
          <a:prstGeom prst="flowChartMagneticDisk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Essential genes dataset 4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6" name="Decision 15"/>
          <p:cNvSpPr/>
          <p:nvPr/>
        </p:nvSpPr>
        <p:spPr>
          <a:xfrm>
            <a:off x="3770573" y="4161428"/>
            <a:ext cx="1598400" cy="986400"/>
          </a:xfrm>
          <a:prstGeom prst="flowChartDecision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datasets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18" name="Elbow Connector 17"/>
          <p:cNvCxnSpPr>
            <a:stCxn id="13" idx="1"/>
            <a:endCxn id="16" idx="2"/>
          </p:cNvCxnSpPr>
          <p:nvPr/>
        </p:nvCxnSpPr>
        <p:spPr>
          <a:xfrm rot="5400000" flipH="1" flipV="1">
            <a:off x="3964028" y="5265934"/>
            <a:ext cx="723851" cy="487640"/>
          </a:xfrm>
          <a:prstGeom prst="bentConnector3">
            <a:avLst>
              <a:gd name="adj1" fmla="val 50000"/>
            </a:avLst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Elbow Connector 19"/>
          <p:cNvCxnSpPr>
            <a:stCxn id="14" idx="1"/>
            <a:endCxn id="16" idx="2"/>
          </p:cNvCxnSpPr>
          <p:nvPr/>
        </p:nvCxnSpPr>
        <p:spPr>
          <a:xfrm rot="16200000" flipV="1">
            <a:off x="4450848" y="5266754"/>
            <a:ext cx="723851" cy="485999"/>
          </a:xfrm>
          <a:prstGeom prst="bentConnector3">
            <a:avLst>
              <a:gd name="adj1" fmla="val 50000"/>
            </a:avLst>
          </a:prstGeom>
          <a:ln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Elbow Connector 28"/>
          <p:cNvCxnSpPr>
            <a:stCxn id="15" idx="1"/>
            <a:endCxn id="16" idx="2"/>
          </p:cNvCxnSpPr>
          <p:nvPr/>
        </p:nvCxnSpPr>
        <p:spPr>
          <a:xfrm rot="16200000" flipV="1">
            <a:off x="4936847" y="4780754"/>
            <a:ext cx="723852" cy="1457999"/>
          </a:xfrm>
          <a:prstGeom prst="bentConnector3">
            <a:avLst>
              <a:gd name="adj1" fmla="val 50000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Elbow Connector 30"/>
          <p:cNvCxnSpPr>
            <a:stCxn id="12" idx="1"/>
            <a:endCxn id="16" idx="2"/>
          </p:cNvCxnSpPr>
          <p:nvPr/>
        </p:nvCxnSpPr>
        <p:spPr>
          <a:xfrm rot="5400000" flipH="1" flipV="1">
            <a:off x="3478027" y="4779934"/>
            <a:ext cx="723852" cy="1459640"/>
          </a:xfrm>
          <a:prstGeom prst="bentConnector3">
            <a:avLst>
              <a:gd name="adj1" fmla="val 50000"/>
            </a:avLst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Connector 32"/>
          <p:cNvSpPr/>
          <p:nvPr/>
        </p:nvSpPr>
        <p:spPr>
          <a:xfrm>
            <a:off x="5974487" y="4328827"/>
            <a:ext cx="1566000" cy="651600"/>
          </a:xfrm>
          <a:prstGeom prst="flowChartConnector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Stringent criterion for gene essentiality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34" name="Straight Arrow Connector 33"/>
          <p:cNvCxnSpPr>
            <a:stCxn id="16" idx="3"/>
            <a:endCxn id="33" idx="2"/>
          </p:cNvCxnSpPr>
          <p:nvPr/>
        </p:nvCxnSpPr>
        <p:spPr>
          <a:xfrm flipV="1">
            <a:off x="5368973" y="4654627"/>
            <a:ext cx="605514" cy="1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Connector 36"/>
          <p:cNvSpPr/>
          <p:nvPr/>
        </p:nvSpPr>
        <p:spPr>
          <a:xfrm>
            <a:off x="1615448" y="4334505"/>
            <a:ext cx="1566000" cy="651600"/>
          </a:xfrm>
          <a:prstGeom prst="flowChartConnector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Tolerant criterion for gene essentiality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38" name="Straight Arrow Connector 37"/>
          <p:cNvCxnSpPr>
            <a:stCxn id="16" idx="1"/>
            <a:endCxn id="37" idx="6"/>
          </p:cNvCxnSpPr>
          <p:nvPr/>
        </p:nvCxnSpPr>
        <p:spPr>
          <a:xfrm rot="10800000" flipV="1">
            <a:off x="3181449" y="4654627"/>
            <a:ext cx="589125" cy="5677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3358548" y="4408407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3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515322" y="4408406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4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52" name="Connector 51"/>
          <p:cNvSpPr/>
          <p:nvPr/>
        </p:nvSpPr>
        <p:spPr>
          <a:xfrm>
            <a:off x="4100133" y="3049104"/>
            <a:ext cx="936000" cy="561600"/>
          </a:xfrm>
          <a:prstGeom prst="flowChartConnector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Discard data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55" name="Straight Arrow Connector 54"/>
          <p:cNvCxnSpPr>
            <a:stCxn id="16" idx="0"/>
            <a:endCxn id="52" idx="4"/>
          </p:cNvCxnSpPr>
          <p:nvPr/>
        </p:nvCxnSpPr>
        <p:spPr>
          <a:xfrm rot="16200000" flipV="1">
            <a:off x="4293591" y="3885246"/>
            <a:ext cx="550724" cy="164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4584351" y="3824879"/>
            <a:ext cx="3211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&lt;3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59" name="Decision 58"/>
          <p:cNvSpPr/>
          <p:nvPr/>
        </p:nvSpPr>
        <p:spPr>
          <a:xfrm>
            <a:off x="1597686" y="2838479"/>
            <a:ext cx="1598400" cy="986400"/>
          </a:xfrm>
          <a:prstGeom prst="flowChartDecision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both datasets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61" name="Straight Arrow Connector 60"/>
          <p:cNvCxnSpPr>
            <a:stCxn id="22" idx="4"/>
            <a:endCxn id="59" idx="0"/>
          </p:cNvCxnSpPr>
          <p:nvPr/>
        </p:nvCxnSpPr>
        <p:spPr>
          <a:xfrm rot="16200000" flipH="1">
            <a:off x="2139306" y="2580899"/>
            <a:ext cx="507840" cy="731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>
            <a:stCxn id="37" idx="0"/>
            <a:endCxn id="59" idx="2"/>
          </p:cNvCxnSpPr>
          <p:nvPr/>
        </p:nvCxnSpPr>
        <p:spPr>
          <a:xfrm rot="16200000" flipV="1">
            <a:off x="2142854" y="4078911"/>
            <a:ext cx="509626" cy="156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>
            <a:stCxn id="59" idx="3"/>
            <a:endCxn id="52" idx="2"/>
          </p:cNvCxnSpPr>
          <p:nvPr/>
        </p:nvCxnSpPr>
        <p:spPr>
          <a:xfrm flipV="1">
            <a:off x="3196086" y="3329904"/>
            <a:ext cx="904047" cy="177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3406030" y="3085458"/>
            <a:ext cx="426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YES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67" name="Decision 66"/>
          <p:cNvSpPr/>
          <p:nvPr/>
        </p:nvSpPr>
        <p:spPr>
          <a:xfrm>
            <a:off x="5956795" y="2830541"/>
            <a:ext cx="1598400" cy="986400"/>
          </a:xfrm>
          <a:prstGeom prst="flowChartDecision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both datasets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68" name="Straight Arrow Connector 67"/>
          <p:cNvCxnSpPr>
            <a:stCxn id="21" idx="4"/>
            <a:endCxn id="67" idx="0"/>
          </p:cNvCxnSpPr>
          <p:nvPr/>
        </p:nvCxnSpPr>
        <p:spPr>
          <a:xfrm rot="16200000" flipH="1">
            <a:off x="6505263" y="2579808"/>
            <a:ext cx="499903" cy="156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>
            <a:stCxn id="33" idx="0"/>
            <a:endCxn id="67" idx="2"/>
          </p:cNvCxnSpPr>
          <p:nvPr/>
        </p:nvCxnSpPr>
        <p:spPr>
          <a:xfrm rot="16200000" flipV="1">
            <a:off x="6500798" y="4072138"/>
            <a:ext cx="511886" cy="1492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>
            <a:stCxn id="67" idx="1"/>
            <a:endCxn id="52" idx="6"/>
          </p:cNvCxnSpPr>
          <p:nvPr/>
        </p:nvCxnSpPr>
        <p:spPr>
          <a:xfrm rot="10800000" flipV="1">
            <a:off x="5036133" y="3323740"/>
            <a:ext cx="920662" cy="6163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5306582" y="3085458"/>
            <a:ext cx="426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YES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40" name="Connector 39"/>
          <p:cNvSpPr/>
          <p:nvPr/>
        </p:nvSpPr>
        <p:spPr>
          <a:xfrm>
            <a:off x="255051" y="3050879"/>
            <a:ext cx="936000" cy="561600"/>
          </a:xfrm>
          <a:prstGeom prst="flowChartConnector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Tolerant criterion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75" name="Straight Arrow Connector 74"/>
          <p:cNvCxnSpPr>
            <a:stCxn id="59" idx="1"/>
            <a:endCxn id="40" idx="6"/>
          </p:cNvCxnSpPr>
          <p:nvPr/>
        </p:nvCxnSpPr>
        <p:spPr>
          <a:xfrm rot="10800000">
            <a:off x="1191052" y="3331679"/>
            <a:ext cx="406635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1223855" y="3071654"/>
            <a:ext cx="3827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NO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77" name="Connector 76"/>
          <p:cNvSpPr/>
          <p:nvPr/>
        </p:nvSpPr>
        <p:spPr>
          <a:xfrm>
            <a:off x="7956218" y="3041053"/>
            <a:ext cx="936000" cy="561600"/>
          </a:xfrm>
          <a:prstGeom prst="flowChartConnector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Stringent criterion</a:t>
            </a:r>
            <a:endParaRPr lang="en-US" sz="1000" dirty="0">
              <a:latin typeface="Times New Roman"/>
              <a:cs typeface="Times New Roman"/>
            </a:endParaRPr>
          </a:p>
        </p:txBody>
      </p:sp>
      <p:cxnSp>
        <p:nvCxnSpPr>
          <p:cNvPr id="79" name="Straight Arrow Connector 78"/>
          <p:cNvCxnSpPr>
            <a:stCxn id="67" idx="3"/>
            <a:endCxn id="77" idx="2"/>
          </p:cNvCxnSpPr>
          <p:nvPr/>
        </p:nvCxnSpPr>
        <p:spPr>
          <a:xfrm flipV="1">
            <a:off x="7555195" y="3321853"/>
            <a:ext cx="401023" cy="18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7537433" y="3083683"/>
            <a:ext cx="3827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Times New Roman"/>
                <a:cs typeface="Times New Roman"/>
              </a:rPr>
              <a:t>NO</a:t>
            </a:r>
            <a:endParaRPr lang="en-US" sz="1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79018470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Macintosh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Lovell</dc:creator>
  <cp:lastModifiedBy>Simon Lovell</cp:lastModifiedBy>
  <cp:revision>2</cp:revision>
  <dcterms:created xsi:type="dcterms:W3CDTF">2013-04-04T14:31:23Z</dcterms:created>
  <dcterms:modified xsi:type="dcterms:W3CDTF">2013-04-04T14:32:17Z</dcterms:modified>
</cp:coreProperties>
</file>